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4"/>
  </p:notesMasterIdLst>
  <p:sldIdLst>
    <p:sldId id="408" r:id="rId2"/>
    <p:sldId id="405" r:id="rId3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y, Karen" initials="LK" lastIdx="1" clrIdx="0">
    <p:extLst>
      <p:ext uri="{19B8F6BF-5375-455C-9EA6-DF929625EA0E}">
        <p15:presenceInfo xmlns:p15="http://schemas.microsoft.com/office/powerpoint/2012/main" userId="Liby, Kar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E19ACEB-5223-4A24-919E-2149F2638296}" v="2" dt="2022-12-20T16:44:41.51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3979" autoAdjust="0"/>
  </p:normalViewPr>
  <p:slideViewPr>
    <p:cSldViewPr snapToGrid="0">
      <p:cViewPr varScale="1">
        <p:scale>
          <a:sx n="38" d="100"/>
          <a:sy n="38" d="100"/>
        </p:scale>
        <p:origin x="166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ynds\Desktop\Liby%20Lab\2022-03-08%20-%20atp%20Mat1a%20Col6a3%2042011%20Bex%20125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ynds\Desktop\Liby%20Lab\2022-03-09%20Krt19%20Adam23%20IL18%2042011%20Bex%20125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 b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6a3</a:t>
            </a:r>
          </a:p>
        </c:rich>
      </c:tx>
      <c:layout>
        <c:manualLayout>
          <c:xMode val="edge"/>
          <c:yMode val="edge"/>
          <c:x val="0.38420084821594458"/>
          <c:y val="9.308096707632639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Analysis!$M$5,Analysis!$S$5)</c:f>
                <c:numCache>
                  <c:formatCode>General</c:formatCode>
                  <c:ptCount val="2"/>
                  <c:pt idx="0">
                    <c:v>0.39812432215239668</c:v>
                  </c:pt>
                  <c:pt idx="1">
                    <c:v>0.480353311740512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(Analysis!$K$18,Analysis!$M$18)</c:f>
              <c:strCache>
                <c:ptCount val="2"/>
                <c:pt idx="0">
                  <c:v>Control</c:v>
                </c:pt>
                <c:pt idx="1">
                  <c:v>Bexarotene</c:v>
                </c:pt>
              </c:strCache>
            </c:strRef>
          </c:cat>
          <c:val>
            <c:numRef>
              <c:f>(Analysis!$K$21,Analysis!$M$21)</c:f>
              <c:numCache>
                <c:formatCode>#,##0.00000</c:formatCode>
                <c:ptCount val="2"/>
                <c:pt idx="0" formatCode="General">
                  <c:v>1</c:v>
                </c:pt>
                <c:pt idx="1">
                  <c:v>1.43821311938017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4D-43D0-9A2C-B0A7DDB2E3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3661416"/>
        <c:axId val="1"/>
      </c:barChart>
      <c:catAx>
        <c:axId val="433661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mRNA Expression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3661416"/>
        <c:crosses val="autoZero"/>
        <c:crossBetween val="between"/>
        <c:majorUnit val="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/>
              <a:t>IL-18</a:t>
            </a:r>
          </a:p>
        </c:rich>
      </c:tx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Analysis!$L$5,Analysis!$R$5)</c:f>
                <c:numCache>
                  <c:formatCode>General</c:formatCode>
                  <c:ptCount val="2"/>
                  <c:pt idx="0">
                    <c:v>0.14601815357571843</c:v>
                  </c:pt>
                  <c:pt idx="1">
                    <c:v>0.516012628882099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(Analysis!$J$18,Analysis!$L$18)</c:f>
              <c:strCache>
                <c:ptCount val="2"/>
                <c:pt idx="0">
                  <c:v>Control</c:v>
                </c:pt>
                <c:pt idx="1">
                  <c:v>Bexarotene</c:v>
                </c:pt>
              </c:strCache>
            </c:strRef>
          </c:cat>
          <c:val>
            <c:numRef>
              <c:f>(Analysis!$J$21,Analysis!$L$21)</c:f>
              <c:numCache>
                <c:formatCode>#,##0.00000</c:formatCode>
                <c:ptCount val="2"/>
                <c:pt idx="0" formatCode="General">
                  <c:v>1</c:v>
                </c:pt>
                <c:pt idx="1">
                  <c:v>0.598517424612269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13-4B95-90BB-585577B40F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3903856"/>
        <c:axId val="1"/>
      </c:barChart>
      <c:catAx>
        <c:axId val="373903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Relative mRNA Expression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373903856"/>
        <c:crosses val="autoZero"/>
        <c:crossBetween val="between"/>
        <c:majorUnit val="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FDB938-A973-4B64-A111-A77DCC90B588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A8D45B-6DA0-4628-A335-42F92FD04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932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1pPr>
    <a:lvl2pPr marL="326144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2pPr>
    <a:lvl3pPr marL="652289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3pPr>
    <a:lvl4pPr marL="978433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4pPr>
    <a:lvl5pPr marL="1304577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5pPr>
    <a:lvl6pPr marL="1630722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6pPr>
    <a:lvl7pPr marL="1956866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7pPr>
    <a:lvl8pPr marL="2283011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8pPr>
    <a:lvl9pPr marL="2609155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9DC267-7B31-4E9D-978A-7E41821641B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842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D92A25-C5EC-499F-838C-2101A5A37AA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460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224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616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08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685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035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488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240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333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559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357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913F5-0CA4-4D40-8F6C-B94AF760EF83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876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chart" Target="../charts/chart1.xml"/><Relationship Id="rId7" Type="http://schemas.openxmlformats.org/officeDocument/2006/relationships/image" Target="../media/image6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81DFFD53-6806-4C71-8972-E979FDF39C28}"/>
              </a:ext>
            </a:extLst>
          </p:cNvPr>
          <p:cNvSpPr txBox="1"/>
          <p:nvPr/>
        </p:nvSpPr>
        <p:spPr>
          <a:xfrm>
            <a:off x="0" y="8376284"/>
            <a:ext cx="7743076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SU 42011 and bexarotene regulate cancer-relevant biological pathways in MMTV-Neu tumors. 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male MMTV-Neu mice with established mammary tumors 4 mm in diameter were fed control diet, bexarotene (100 mg/kg in diet), or MSU 42011 (100 mg/kg in diet) for 10 days. The Wikipathways 2019 mouse database was used for enrichment analysis. 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Bar graph of top differentially expressed pathways. Scatterplot (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volcano plot (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f top differentially expressed pathways.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endParaRPr lang="en-US" sz="12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CC1ED10-B099-41D8-83B0-5E4105BDE817}"/>
              </a:ext>
            </a:extLst>
          </p:cNvPr>
          <p:cNvSpPr txBox="1"/>
          <p:nvPr/>
        </p:nvSpPr>
        <p:spPr>
          <a:xfrm>
            <a:off x="-52271" y="-74450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FDDEF6E-7B8E-48E0-847C-AED996A6634A}"/>
              </a:ext>
            </a:extLst>
          </p:cNvPr>
          <p:cNvSpPr txBox="1"/>
          <p:nvPr/>
        </p:nvSpPr>
        <p:spPr>
          <a:xfrm>
            <a:off x="1464" y="4018935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1EAA50-FD98-47CD-AB7C-6B73495345B6}"/>
              </a:ext>
            </a:extLst>
          </p:cNvPr>
          <p:cNvSpPr txBox="1"/>
          <p:nvPr/>
        </p:nvSpPr>
        <p:spPr>
          <a:xfrm>
            <a:off x="3709871" y="4018935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909770AC-D465-5AFD-B755-0777D7F09FE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766" y="123251"/>
            <a:ext cx="7326233" cy="4018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Scatter chart&#10;&#10;Description automatically generated">
            <a:extLst>
              <a:ext uri="{FF2B5EF4-FFF2-40B4-BE49-F238E27FC236}">
                <a16:creationId xmlns:a16="http://schemas.microsoft.com/office/drawing/2014/main" id="{5D4633A8-9CAA-8C4E-2B11-B2505DDF4F8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85293"/>
            <a:ext cx="3838467" cy="3552577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4E7684E5-8367-B50C-BF14-9E3A8869977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961"/>
          <a:stretch/>
        </p:blipFill>
        <p:spPr>
          <a:xfrm>
            <a:off x="3838467" y="4485293"/>
            <a:ext cx="3893217" cy="35525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5150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7" name="Chart 66">
            <a:extLst>
              <a:ext uri="{FF2B5EF4-FFF2-40B4-BE49-F238E27FC236}">
                <a16:creationId xmlns:a16="http://schemas.microsoft.com/office/drawing/2014/main" id="{513B4305-010A-4936-85F9-FDC7B83BD4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5709313"/>
              </p:ext>
            </p:extLst>
          </p:nvPr>
        </p:nvGraphicFramePr>
        <p:xfrm>
          <a:off x="0" y="5013089"/>
          <a:ext cx="3502384" cy="34880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2" name="Chart 51">
            <a:extLst>
              <a:ext uri="{FF2B5EF4-FFF2-40B4-BE49-F238E27FC236}">
                <a16:creationId xmlns:a16="http://schemas.microsoft.com/office/drawing/2014/main" id="{02C41F7D-7D5D-40F8-ABF8-80ED2AED36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8919214"/>
              </p:ext>
            </p:extLst>
          </p:nvPr>
        </p:nvGraphicFramePr>
        <p:xfrm>
          <a:off x="-17530" y="677338"/>
          <a:ext cx="3534033" cy="3260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TextBox 22">
            <a:extLst>
              <a:ext uri="{FF2B5EF4-FFF2-40B4-BE49-F238E27FC236}">
                <a16:creationId xmlns:a16="http://schemas.microsoft.com/office/drawing/2014/main" id="{FF9F7763-BD94-4DAB-A45E-BCBCA1C5B13C}"/>
              </a:ext>
            </a:extLst>
          </p:cNvPr>
          <p:cNvSpPr txBox="1"/>
          <p:nvPr/>
        </p:nvSpPr>
        <p:spPr>
          <a:xfrm>
            <a:off x="0" y="9294384"/>
            <a:ext cx="7772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xarotene does not increase expression of IL-18 and Col6a3 in mouse mammary tumors. 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mors treated with bexarotene (100 mg/kg diet) or control were harvested and flash-frozen. Tumors were homogenized and RNA extracted. 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, C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Gene expression was detected by qPCR. N=5 mice/group. Error bars represent standard error. * p &lt; 0.05  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, D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Immunohistochemical staining for IL-18 and Col6a3, representative of 3 mice per group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239D68C-A18C-471A-8697-E27761A41CB0}"/>
              </a:ext>
            </a:extLst>
          </p:cNvPr>
          <p:cNvSpPr txBox="1"/>
          <p:nvPr/>
        </p:nvSpPr>
        <p:spPr>
          <a:xfrm>
            <a:off x="-52271" y="-74450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6D2ED4D-DDE8-2865-FDD6-0A65EB76E3F7}"/>
              </a:ext>
            </a:extLst>
          </p:cNvPr>
          <p:cNvSpPr txBox="1"/>
          <p:nvPr/>
        </p:nvSpPr>
        <p:spPr>
          <a:xfrm>
            <a:off x="3678410" y="5648054"/>
            <a:ext cx="1287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E8E0884-3ADB-EAE3-BD40-5DB9D13546D2}"/>
              </a:ext>
            </a:extLst>
          </p:cNvPr>
          <p:cNvSpPr txBox="1"/>
          <p:nvPr/>
        </p:nvSpPr>
        <p:spPr>
          <a:xfrm>
            <a:off x="4105764" y="7989578"/>
            <a:ext cx="1287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ex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06BB7EDB-B8D2-81F3-D18C-4FA881578E1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6778" y="4714181"/>
            <a:ext cx="2985906" cy="224028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0BF5E3D8-F474-B910-9943-555E247262F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6778" y="7054104"/>
            <a:ext cx="2985905" cy="2240280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39786F8A-2AD8-4F60-23FF-C2F49112885A}"/>
              </a:ext>
            </a:extLst>
          </p:cNvPr>
          <p:cNvSpPr txBox="1"/>
          <p:nvPr/>
        </p:nvSpPr>
        <p:spPr>
          <a:xfrm>
            <a:off x="3579162" y="991604"/>
            <a:ext cx="1269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C482935-BE39-774E-564D-C52D40B2A7AA}"/>
              </a:ext>
            </a:extLst>
          </p:cNvPr>
          <p:cNvSpPr txBox="1"/>
          <p:nvPr/>
        </p:nvSpPr>
        <p:spPr>
          <a:xfrm>
            <a:off x="3978389" y="3319829"/>
            <a:ext cx="878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ex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4AAA9A5A-ABFF-2A28-E8BF-9AA8390B635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6778" y="56130"/>
            <a:ext cx="2985906" cy="224028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19F55510-8012-391B-53A0-C2630C10086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6778" y="2385155"/>
            <a:ext cx="2985905" cy="2240280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30F312D6-C57B-E7F0-C1AE-5D7FB0E882ED}"/>
              </a:ext>
            </a:extLst>
          </p:cNvPr>
          <p:cNvSpPr txBox="1"/>
          <p:nvPr/>
        </p:nvSpPr>
        <p:spPr>
          <a:xfrm>
            <a:off x="-17530" y="4604988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FCC2B77-8347-9986-999E-6FDFE52F9067}"/>
              </a:ext>
            </a:extLst>
          </p:cNvPr>
          <p:cNvSpPr txBox="1"/>
          <p:nvPr/>
        </p:nvSpPr>
        <p:spPr>
          <a:xfrm>
            <a:off x="2997229" y="-68323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71BD789-C96E-87AD-05B6-2B18A110E234}"/>
              </a:ext>
            </a:extLst>
          </p:cNvPr>
          <p:cNvSpPr txBox="1"/>
          <p:nvPr/>
        </p:nvSpPr>
        <p:spPr>
          <a:xfrm>
            <a:off x="2997229" y="4562197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84452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909</TotalTime>
  <Words>201</Words>
  <Application>Microsoft Office PowerPoint</Application>
  <PresentationFormat>Custom</PresentationFormat>
  <Paragraphs>19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-125 Paper Figures</dc:title>
  <dc:creator>Reich, Lyndsey</dc:creator>
  <cp:lastModifiedBy>Liby, Karen</cp:lastModifiedBy>
  <cp:revision>503</cp:revision>
  <dcterms:created xsi:type="dcterms:W3CDTF">2021-01-05T15:19:41Z</dcterms:created>
  <dcterms:modified xsi:type="dcterms:W3CDTF">2023-01-15T18:03:40Z</dcterms:modified>
</cp:coreProperties>
</file>